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78" r:id="rId3"/>
    <p:sldId id="27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DC0A0B-D385-4050-9860-04197A4D74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604019-1B7C-FDA2-8B8B-A91927D549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2CE8A8-4D20-D91B-6E0F-53B247E64C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B0921A-A8F5-8978-0D65-70C085355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77E71-5B26-C540-D36A-4BAB312EDB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97476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B92151-8B14-174B-DD9B-701FB21955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D4EA35-26D3-2B86-5327-D317BB8923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271FAF-94EA-6236-D8CB-8564E928DF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6C5765-7C34-D249-CE20-98B73B7382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9F8A50-60EA-2F61-9108-DD451334E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3609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F833738-5826-AE9C-D59F-D575E5DF3E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8BACDE-D076-1BC0-1DFB-B1F1613ADA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DCCD85-FA89-2FDF-FDC0-A5AE1D0B8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0AB545-1BE8-A980-6626-02EAF4E99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9E8BAC-736B-7134-7FAF-BEA707821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2554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D21024-DB66-271C-5BC6-437494D0FF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379611-8074-CD4B-57FB-F0B41D487F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2300D1-CC7D-837F-3C64-86D235D58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7690AD-B18A-44CF-E9BE-BDE94CC70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3BCC3B-5551-BB36-3B69-2E57DE660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33030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6470B-316A-FF26-7298-F7F325804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77B16C-752D-7C1D-C4C5-6CD0D29143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5F4C9F-FD12-4E13-0679-946958DF6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26002A-6B27-9FA7-B530-8852DEB1F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2ECEA7-48A3-1477-7482-EC0EFC5FB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7599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307FC5-FEDC-07DF-60FD-0A0D34219B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31798A-9AEC-AF20-9C13-E2E8333568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91F74F-6D7A-DA72-8181-65B843131C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1CCF4C-13BA-2243-727D-FB45FC910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B4D998-7366-532B-C2E2-3EB65089D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098D0F-478A-5F84-7632-C4149A2DE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89023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38674C-A2F3-C784-969D-1218FC6C92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161FCF-22D1-5B2F-CCD1-5FBEB70DC8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77F2BE-1DFD-8282-C0D5-3326B2C0F7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0E8B18-9985-30D8-BFB9-2EDBB9A517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52FF00-F578-3B9F-ED6D-FC8699162A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D48C0A-23A4-F6E0-7446-F8F027411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B6B9556-74B3-AF8E-C6B6-0DEB9D21E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77633E-4DE1-B182-7455-C08122895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8147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D3EA0-D698-4ECE-6D1D-1EB8B1AAEB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4B4952-99FF-450E-BDEB-20261951D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00A8E64-8665-77BC-B2D6-D558DA72EE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1583E31-72EE-0E28-F8CD-D95F6AB71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6268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CC46B6-E2C4-0568-CB40-544C4DA9F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F2854C-3293-F293-66DF-663E58E28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398FA7-3225-17D5-88D3-C9B6E6077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9979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F07E8A-B89E-A286-D664-F8362E5036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08060D-1395-9019-F7B5-F5C69AB306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F25FAE-9BB1-4147-BB36-AD128EF970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27AC33-94AC-088B-09DB-5D46AD78D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DE03FC-9CBF-079C-B557-FEE887882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5A4E95-56C9-5C92-609A-5D88B9107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67400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94CA41-AB65-AE89-DF6B-46FE5233F1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06E717-DC60-0EE1-86BE-3C3C6B69DC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531288-CB79-2E86-EBE9-345517E584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C34899-C398-1113-120C-B84CCAFBD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5D6DB4-4722-6207-1A0C-6BCFF0597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C48FF9-2C3E-5281-A1D3-B8ADB5CDC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30931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4A4BCA-549E-6CF5-EE0D-F3CC03F288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D92086-95C0-943A-BA59-BAF88ED40F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965C29-093C-25DB-6DE2-6B7E5F99B3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7DCAB-0F88-4965-B1BC-38A7B375C57F}" type="datetimeFigureOut">
              <a:rPr lang="en-IN" smtClean="0"/>
              <a:t>02-01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DDFC6B-966E-24E0-8311-5C634BFA12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19B9DD-2648-7EB4-F4AB-D529C443FB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6D3231-C88A-4D24-84A7-8121AB22CB5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5877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3C5AEC1-00A1-8F6A-C505-B8366B0BE7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2693" y="641111"/>
            <a:ext cx="8746981" cy="4243537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603CCC1-C2E4-5612-F84F-0BB17DA594D7}"/>
              </a:ext>
            </a:extLst>
          </p:cNvPr>
          <p:cNvSpPr/>
          <p:nvPr/>
        </p:nvSpPr>
        <p:spPr>
          <a:xfrm>
            <a:off x="9215919" y="770562"/>
            <a:ext cx="792991" cy="5856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12573AB-ECBC-28D4-C630-2F4CCDEBA787}"/>
              </a:ext>
            </a:extLst>
          </p:cNvPr>
          <p:cNvSpPr txBox="1"/>
          <p:nvPr/>
        </p:nvSpPr>
        <p:spPr>
          <a:xfrm>
            <a:off x="1231222" y="5111476"/>
            <a:ext cx="90408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ure 1- A: Functional annotations of DEGs in the leaf of pearl millet seedlings under heat stress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ditions.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graphical picture represented the most significant terms under each category viz., biological process (green), cellular component (orange), molecular function (blue).</a:t>
            </a:r>
          </a:p>
          <a:p>
            <a:pPr algn="just"/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9A4E49B-CF1F-E263-D847-23FEAAC0DD95}"/>
              </a:ext>
            </a:extLst>
          </p:cNvPr>
          <p:cNvSpPr txBox="1"/>
          <p:nvPr/>
        </p:nvSpPr>
        <p:spPr>
          <a:xfrm>
            <a:off x="913506" y="2762879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9503262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D2AB999-A9A9-008F-B3A8-E0ED19FDEC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951" y="784943"/>
            <a:ext cx="8743270" cy="42444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6C765DC-82A2-D39B-E2B7-AE2D39F8E70A}"/>
              </a:ext>
            </a:extLst>
          </p:cNvPr>
          <p:cNvSpPr txBox="1"/>
          <p:nvPr/>
        </p:nvSpPr>
        <p:spPr>
          <a:xfrm>
            <a:off x="1163422" y="5160312"/>
            <a:ext cx="87539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ure 1- B: Functional annotations of DEGs in the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ot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pearl millet seedlings under heat stress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ditions.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graphical picture represented the most significant terms under each category viz., biological process (green), cellular component (orange), molecular function (blue).</a:t>
            </a:r>
          </a:p>
          <a:p>
            <a:pPr algn="just"/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41830E7-A2DE-AB53-D315-6FD6E877085B}"/>
              </a:ext>
            </a:extLst>
          </p:cNvPr>
          <p:cNvSpPr/>
          <p:nvPr/>
        </p:nvSpPr>
        <p:spPr>
          <a:xfrm>
            <a:off x="9232968" y="866691"/>
            <a:ext cx="792991" cy="5856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D51E3B-58B4-9F7A-5E00-06EEF63B7459}"/>
              </a:ext>
            </a:extLst>
          </p:cNvPr>
          <p:cNvSpPr txBox="1"/>
          <p:nvPr/>
        </p:nvSpPr>
        <p:spPr>
          <a:xfrm>
            <a:off x="913506" y="2762879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6978578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E5E427A-E805-CBD6-6C45-119DD5E2AF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4258" y="944545"/>
            <a:ext cx="8737261" cy="42444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2047899-6D4D-75BD-159E-8CBBF8F0C2FC}"/>
              </a:ext>
            </a:extLst>
          </p:cNvPr>
          <p:cNvSpPr/>
          <p:nvPr/>
        </p:nvSpPr>
        <p:spPr>
          <a:xfrm>
            <a:off x="9297400" y="1159861"/>
            <a:ext cx="792991" cy="5856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F251851-C827-FCFF-44E5-D33293110E03}"/>
              </a:ext>
            </a:extLst>
          </p:cNvPr>
          <p:cNvSpPr txBox="1"/>
          <p:nvPr/>
        </p:nvSpPr>
        <p:spPr>
          <a:xfrm>
            <a:off x="976444" y="5463081"/>
            <a:ext cx="885395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ure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- C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Functional annotations of DEGs in the leaf </a:t>
            </a:r>
            <a:r>
              <a:rPr lang="en-IN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s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ot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pearl millet seedlings under heat stress </a:t>
            </a:r>
            <a:r>
              <a:rPr lang="en-IN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ditions.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graphical picture represented the most significant terms under each category viz., biological process (green), cellular component (orange), molecular function (blue).</a:t>
            </a:r>
          </a:p>
          <a:p>
            <a:pPr algn="just"/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3FA6294-BA31-550B-EC04-7FDB74744E56}"/>
              </a:ext>
            </a:extLst>
          </p:cNvPr>
          <p:cNvSpPr txBox="1"/>
          <p:nvPr/>
        </p:nvSpPr>
        <p:spPr>
          <a:xfrm>
            <a:off x="924943" y="2882079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)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276466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5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HA NARAYANAN</dc:creator>
  <cp:lastModifiedBy>NEHA NARAYANAN</cp:lastModifiedBy>
  <cp:revision>1</cp:revision>
  <dcterms:created xsi:type="dcterms:W3CDTF">2024-01-02T06:12:18Z</dcterms:created>
  <dcterms:modified xsi:type="dcterms:W3CDTF">2024-01-02T06:12:36Z</dcterms:modified>
</cp:coreProperties>
</file>